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101" d="100"/>
          <a:sy n="101" d="100"/>
        </p:scale>
        <p:origin x="-2024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5561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02500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29922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0189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01923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14681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66921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7605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22287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32031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5209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06805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00894433"/>
              </p:ext>
            </p:extLst>
          </p:nvPr>
        </p:nvGraphicFramePr>
        <p:xfrm>
          <a:off x="2590800" y="2438400"/>
          <a:ext cx="3105150" cy="2430620"/>
        </p:xfrm>
        <a:graphic>
          <a:graphicData uri="http://schemas.openxmlformats.org/drawingml/2006/table">
            <a:tbl>
              <a:tblPr/>
              <a:tblGrid>
                <a:gridCol w="1552575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552575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</a:tblGrid>
              <a:tr h="9582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GFP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lncEGFL7OS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49079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0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88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49079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88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2.18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49079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9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effectLst/>
                          <a:latin typeface="Arial"/>
                        </a:rPr>
                        <a:t>1.9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609600" y="1143000"/>
            <a:ext cx="308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5-figure supplement 2A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338982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4891024"/>
              </p:ext>
            </p:extLst>
          </p:nvPr>
        </p:nvGraphicFramePr>
        <p:xfrm>
          <a:off x="3124200" y="2743200"/>
          <a:ext cx="2571750" cy="2278220"/>
        </p:xfrm>
        <a:graphic>
          <a:graphicData uri="http://schemas.openxmlformats.org/drawingml/2006/table">
            <a:tbl>
              <a:tblPr/>
              <a:tblGrid>
                <a:gridCol w="1285875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285875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</a:tblGrid>
              <a:tr h="89814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effectLst/>
                          <a:latin typeface="Arial"/>
                        </a:rPr>
                        <a:t>GFP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effectLst/>
                          <a:latin typeface="Arial"/>
                        </a:rPr>
                        <a:t>lncEGFL7OS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46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3.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46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3.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46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effectLst/>
                          <a:latin typeface="Arial"/>
                        </a:rPr>
                        <a:t>3.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609600" y="1143000"/>
            <a:ext cx="30747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5-figure supplement 2B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7625295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28</Words>
  <Application>Microsoft Macintosh PowerPoint</Application>
  <PresentationFormat>On-screen Show (4:3)</PresentationFormat>
  <Paragraphs>18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sanna</dc:creator>
  <cp:lastModifiedBy>Susanna</cp:lastModifiedBy>
  <cp:revision>13</cp:revision>
  <dcterms:created xsi:type="dcterms:W3CDTF">2018-12-03T10:45:52Z</dcterms:created>
  <dcterms:modified xsi:type="dcterms:W3CDTF">2018-12-03T11:00:39Z</dcterms:modified>
</cp:coreProperties>
</file>